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4881" autoAdjust="0"/>
    <p:restoredTop sz="94660"/>
  </p:normalViewPr>
  <p:slideViewPr>
    <p:cSldViewPr snapToGrid="0">
      <p:cViewPr>
        <p:scale>
          <a:sx n="100" d="100"/>
          <a:sy n="100" d="100"/>
        </p:scale>
        <p:origin x="-876" y="7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852D8-21E4-4CA0-9880-7C62A5DB6992}" type="datetimeFigureOut">
              <a:rPr kumimoji="1" lang="ja-JP" altLang="en-US" smtClean="0"/>
              <a:t>2016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AC1F-EAEE-4F2D-A354-E82B33C4B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750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852D8-21E4-4CA0-9880-7C62A5DB6992}" type="datetimeFigureOut">
              <a:rPr kumimoji="1" lang="ja-JP" altLang="en-US" smtClean="0"/>
              <a:t>2016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AC1F-EAEE-4F2D-A354-E82B33C4B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2479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852D8-21E4-4CA0-9880-7C62A5DB6992}" type="datetimeFigureOut">
              <a:rPr kumimoji="1" lang="ja-JP" altLang="en-US" smtClean="0"/>
              <a:t>2016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AC1F-EAEE-4F2D-A354-E82B33C4B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1407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852D8-21E4-4CA0-9880-7C62A5DB6992}" type="datetimeFigureOut">
              <a:rPr kumimoji="1" lang="ja-JP" altLang="en-US" smtClean="0"/>
              <a:t>2016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AC1F-EAEE-4F2D-A354-E82B33C4B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20342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852D8-21E4-4CA0-9880-7C62A5DB6992}" type="datetimeFigureOut">
              <a:rPr kumimoji="1" lang="ja-JP" altLang="en-US" smtClean="0"/>
              <a:t>2016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AC1F-EAEE-4F2D-A354-E82B33C4B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5879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852D8-21E4-4CA0-9880-7C62A5DB6992}" type="datetimeFigureOut">
              <a:rPr kumimoji="1" lang="ja-JP" altLang="en-US" smtClean="0"/>
              <a:t>2016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AC1F-EAEE-4F2D-A354-E82B33C4B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4436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852D8-21E4-4CA0-9880-7C62A5DB6992}" type="datetimeFigureOut">
              <a:rPr kumimoji="1" lang="ja-JP" altLang="en-US" smtClean="0"/>
              <a:t>2016/9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AC1F-EAEE-4F2D-A354-E82B33C4B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8532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852D8-21E4-4CA0-9880-7C62A5DB6992}" type="datetimeFigureOut">
              <a:rPr kumimoji="1" lang="ja-JP" altLang="en-US" smtClean="0"/>
              <a:t>2016/9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AC1F-EAEE-4F2D-A354-E82B33C4B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7547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852D8-21E4-4CA0-9880-7C62A5DB6992}" type="datetimeFigureOut">
              <a:rPr kumimoji="1" lang="ja-JP" altLang="en-US" smtClean="0"/>
              <a:t>2016/9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AC1F-EAEE-4F2D-A354-E82B33C4B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9639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852D8-21E4-4CA0-9880-7C62A5DB6992}" type="datetimeFigureOut">
              <a:rPr kumimoji="1" lang="ja-JP" altLang="en-US" smtClean="0"/>
              <a:t>2016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AC1F-EAEE-4F2D-A354-E82B33C4B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6855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6852D8-21E4-4CA0-9880-7C62A5DB6992}" type="datetimeFigureOut">
              <a:rPr kumimoji="1" lang="ja-JP" altLang="en-US" smtClean="0"/>
              <a:t>2016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1AC1F-EAEE-4F2D-A354-E82B33C4B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5470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6852D8-21E4-4CA0-9880-7C62A5DB6992}" type="datetimeFigureOut">
              <a:rPr kumimoji="1" lang="ja-JP" altLang="en-US" smtClean="0"/>
              <a:t>2016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1AC1F-EAEE-4F2D-A354-E82B33C4B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2946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72736" y="5846049"/>
            <a:ext cx="895696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b="1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1 </a:t>
            </a:r>
            <a:r>
              <a:rPr lang="en-US" altLang="ja-JP" sz="14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. Plant images of the 69 accessions</a:t>
            </a: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t 2 weeks after salt treatment.</a:t>
            </a:r>
            <a:endParaRPr lang="ja-JP" altLang="ja-JP" sz="1200" kern="100" dirty="0" smtClean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otos separately taken for every 12 plants were merged for a picture. Plants in control, 50 </a:t>
            </a:r>
            <a:r>
              <a:rPr lang="en-US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M</a:t>
            </a: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aCl</a:t>
            </a: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d 200 </a:t>
            </a:r>
            <a:r>
              <a:rPr lang="en-US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M</a:t>
            </a: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aCl</a:t>
            </a: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t 2 weeks after salt treatment in the 2nd experiment are shown. ID and group of each accession in the pictures are shown in the upper tables.</a:t>
            </a:r>
            <a:r>
              <a:rPr lang="en-US" altLang="ja-JP" sz="1200" kern="100" dirty="0" smtClean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lors of the groups are same as shown in Fig 1.</a:t>
            </a:r>
            <a:endParaRPr lang="ja-JP" altLang="ja-JP" sz="12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0775" y="24299"/>
            <a:ext cx="8297050" cy="589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92889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81</Words>
  <Application>Microsoft Office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seki</dc:creator>
  <cp:lastModifiedBy>井関洸太朗</cp:lastModifiedBy>
  <cp:revision>6</cp:revision>
  <dcterms:created xsi:type="dcterms:W3CDTF">2016-06-08T00:47:33Z</dcterms:created>
  <dcterms:modified xsi:type="dcterms:W3CDTF">2016-09-15T13:39:21Z</dcterms:modified>
</cp:coreProperties>
</file>